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4" autoAdjust="0"/>
    <p:restoredTop sz="89551" autoAdjust="0"/>
  </p:normalViewPr>
  <p:slideViewPr>
    <p:cSldViewPr snapToGrid="0">
      <p:cViewPr varScale="1">
        <p:scale>
          <a:sx n="102" d="100"/>
          <a:sy n="102" d="100"/>
        </p:scale>
        <p:origin x="95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C4AD-D9EA-49F3-BCC8-2ED580C9FD35}" type="datetimeFigureOut">
              <a:rPr lang="en-US" smtClean="0"/>
              <a:t>8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68085-3451-4FBC-854B-40AA99329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473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C4AD-D9EA-49F3-BCC8-2ED580C9FD35}" type="datetimeFigureOut">
              <a:rPr lang="en-US" smtClean="0"/>
              <a:t>8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68085-3451-4FBC-854B-40AA99329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1814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C4AD-D9EA-49F3-BCC8-2ED580C9FD35}" type="datetimeFigureOut">
              <a:rPr lang="en-US" smtClean="0"/>
              <a:t>8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68085-3451-4FBC-854B-40AA99329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727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C4AD-D9EA-49F3-BCC8-2ED580C9FD35}" type="datetimeFigureOut">
              <a:rPr lang="en-US" smtClean="0"/>
              <a:t>8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68085-3451-4FBC-854B-40AA99329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9756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C4AD-D9EA-49F3-BCC8-2ED580C9FD35}" type="datetimeFigureOut">
              <a:rPr lang="en-US" smtClean="0"/>
              <a:t>8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68085-3451-4FBC-854B-40AA99329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5075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C4AD-D9EA-49F3-BCC8-2ED580C9FD35}" type="datetimeFigureOut">
              <a:rPr lang="en-US" smtClean="0"/>
              <a:t>8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68085-3451-4FBC-854B-40AA99329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72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C4AD-D9EA-49F3-BCC8-2ED580C9FD35}" type="datetimeFigureOut">
              <a:rPr lang="en-US" smtClean="0"/>
              <a:t>8/1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68085-3451-4FBC-854B-40AA99329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76198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C4AD-D9EA-49F3-BCC8-2ED580C9FD35}" type="datetimeFigureOut">
              <a:rPr lang="en-US" smtClean="0"/>
              <a:t>8/1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68085-3451-4FBC-854B-40AA99329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0516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C4AD-D9EA-49F3-BCC8-2ED580C9FD35}" type="datetimeFigureOut">
              <a:rPr lang="en-US" smtClean="0"/>
              <a:t>8/1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68085-3451-4FBC-854B-40AA99329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3741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C4AD-D9EA-49F3-BCC8-2ED580C9FD35}" type="datetimeFigureOut">
              <a:rPr lang="en-US" smtClean="0"/>
              <a:t>8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68085-3451-4FBC-854B-40AA99329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7473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C4AD-D9EA-49F3-BCC8-2ED580C9FD35}" type="datetimeFigureOut">
              <a:rPr lang="en-US" smtClean="0"/>
              <a:t>8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68085-3451-4FBC-854B-40AA99329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0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85C4AD-D9EA-49F3-BCC8-2ED580C9FD35}" type="datetimeFigureOut">
              <a:rPr lang="en-US" smtClean="0"/>
              <a:t>8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D68085-3451-4FBC-854B-40AA99329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8532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5">
            <a:extLst>
              <a:ext uri="{FF2B5EF4-FFF2-40B4-BE49-F238E27FC236}">
                <a16:creationId xmlns:a16="http://schemas.microsoft.com/office/drawing/2014/main" id="{E3F9C113-977A-4C80-8BF2-9FB6DEA1F324}"/>
              </a:ext>
            </a:extLst>
          </p:cNvPr>
          <p:cNvPicPr preferRelativeResize="0">
            <a:picLocks noGrp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486917" y="387513"/>
            <a:ext cx="3291840" cy="2743200"/>
          </a:xfrm>
          <a:prstGeom prst="rect">
            <a:avLst/>
          </a:prstGeom>
        </p:spPr>
      </p:pic>
      <p:pic>
        <p:nvPicPr>
          <p:cNvPr id="5" name="Content Placeholder 3">
            <a:extLst>
              <a:ext uri="{FF2B5EF4-FFF2-40B4-BE49-F238E27FC236}">
                <a16:creationId xmlns:a16="http://schemas.microsoft.com/office/drawing/2014/main" id="{60E306F1-9155-4B52-9B16-7DD785CB38EF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942916" y="387513"/>
            <a:ext cx="3291840" cy="2743200"/>
          </a:xfrm>
          <a:prstGeom prst="rect">
            <a:avLst/>
          </a:prstGeom>
        </p:spPr>
      </p:pic>
      <p:pic>
        <p:nvPicPr>
          <p:cNvPr id="6" name="Content Placeholder 5">
            <a:extLst>
              <a:ext uri="{FF2B5EF4-FFF2-40B4-BE49-F238E27FC236}">
                <a16:creationId xmlns:a16="http://schemas.microsoft.com/office/drawing/2014/main" id="{EA3242D0-BEDE-417E-97DF-812507BDE530}"/>
              </a:ext>
            </a:extLst>
          </p:cNvPr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495250" y="3835619"/>
            <a:ext cx="3291840" cy="2743200"/>
          </a:xfrm>
          <a:prstGeom prst="rect">
            <a:avLst/>
          </a:prstGeom>
        </p:spPr>
      </p:pic>
      <p:pic>
        <p:nvPicPr>
          <p:cNvPr id="7" name="Content Placeholder 7">
            <a:extLst>
              <a:ext uri="{FF2B5EF4-FFF2-40B4-BE49-F238E27FC236}">
                <a16:creationId xmlns:a16="http://schemas.microsoft.com/office/drawing/2014/main" id="{9256B9C6-8343-4429-B313-9F15C1B1566D}"/>
              </a:ext>
            </a:extLst>
          </p:cNvPr>
          <p:cNvPicPr preferRelativeResize="0">
            <a:picLocks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942916" y="3835619"/>
            <a:ext cx="3291840" cy="27432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B5C4A3B-7BEF-4AC7-9B0C-030F09FDC0FD}"/>
              </a:ext>
            </a:extLst>
          </p:cNvPr>
          <p:cNvSpPr txBox="1"/>
          <p:nvPr/>
        </p:nvSpPr>
        <p:spPr>
          <a:xfrm>
            <a:off x="3472343" y="18181"/>
            <a:ext cx="35185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 adipose tissue with red staining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45EF2E7-AFE6-4686-A036-5BAA3FF440B0}"/>
              </a:ext>
            </a:extLst>
          </p:cNvPr>
          <p:cNvSpPr txBox="1"/>
          <p:nvPr/>
        </p:nvSpPr>
        <p:spPr>
          <a:xfrm>
            <a:off x="7876116" y="39644"/>
            <a:ext cx="12458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 Smoke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B9BD4D3-B0AB-42C0-A8AC-562D389CF589}"/>
              </a:ext>
            </a:extLst>
          </p:cNvPr>
          <p:cNvSpPr txBox="1"/>
          <p:nvPr/>
        </p:nvSpPr>
        <p:spPr>
          <a:xfrm>
            <a:off x="3370209" y="3230332"/>
            <a:ext cx="34991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c) Never-smoker with acute</a:t>
            </a:r>
          </a:p>
          <a:p>
            <a:r>
              <a:rPr lang="en-US" dirty="0"/>
              <a:t>      bronchopneumoni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8D54B46-FA95-40E1-8C38-26F91648DEB0}"/>
              </a:ext>
            </a:extLst>
          </p:cNvPr>
          <p:cNvSpPr txBox="1"/>
          <p:nvPr/>
        </p:nvSpPr>
        <p:spPr>
          <a:xfrm>
            <a:off x="6942916" y="3383223"/>
            <a:ext cx="3413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d) Lipid-laden Macrophage Index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AF1F67E-5D96-4BC6-B0FA-AAE9AB0DDC0F}"/>
              </a:ext>
            </a:extLst>
          </p:cNvPr>
          <p:cNvSpPr txBox="1"/>
          <p:nvPr/>
        </p:nvSpPr>
        <p:spPr>
          <a:xfrm>
            <a:off x="49329" y="0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41023359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</TotalTime>
  <Words>29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OSU Wexner Medical Center I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lo, Konstantin</dc:creator>
  <cp:lastModifiedBy>Ralph, Hannah K. (ELS-LOW)</cp:lastModifiedBy>
  <cp:revision>12</cp:revision>
  <dcterms:created xsi:type="dcterms:W3CDTF">2020-02-09T19:09:08Z</dcterms:created>
  <dcterms:modified xsi:type="dcterms:W3CDTF">2020-08-14T08:53:36Z</dcterms:modified>
</cp:coreProperties>
</file>